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43" userDrawn="1">
          <p15:clr>
            <a:srgbClr val="A4A3A4"/>
          </p15:clr>
        </p15:guide>
        <p15:guide id="2" pos="231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490" autoAdjust="0"/>
    <p:restoredTop sz="94660"/>
  </p:normalViewPr>
  <p:slideViewPr>
    <p:cSldViewPr snapToGrid="0" showGuides="1">
      <p:cViewPr varScale="1">
        <p:scale>
          <a:sx n="67" d="100"/>
          <a:sy n="67" d="100"/>
        </p:scale>
        <p:origin x="1950" y="78"/>
      </p:cViewPr>
      <p:guideLst>
        <p:guide orient="horz" pos="3143"/>
        <p:guide pos="231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4D6DA-4CD8-4655-B61A-D39712F05FC0}" type="datetimeFigureOut">
              <a:rPr lang="ko-KR" altLang="en-US" smtClean="0"/>
              <a:t>2024-01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C1D3F-BC44-44A1-AF1C-BBEBAB8F4A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556572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4D6DA-4CD8-4655-B61A-D39712F05FC0}" type="datetimeFigureOut">
              <a:rPr lang="ko-KR" altLang="en-US" smtClean="0"/>
              <a:t>2024-01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C1D3F-BC44-44A1-AF1C-BBEBAB8F4A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428667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4D6DA-4CD8-4655-B61A-D39712F05FC0}" type="datetimeFigureOut">
              <a:rPr lang="ko-KR" altLang="en-US" smtClean="0"/>
              <a:t>2024-01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C1D3F-BC44-44A1-AF1C-BBEBAB8F4A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126853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4D6DA-4CD8-4655-B61A-D39712F05FC0}" type="datetimeFigureOut">
              <a:rPr lang="ko-KR" altLang="en-US" smtClean="0"/>
              <a:t>2024-01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C1D3F-BC44-44A1-AF1C-BBEBAB8F4A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94994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4D6DA-4CD8-4655-B61A-D39712F05FC0}" type="datetimeFigureOut">
              <a:rPr lang="ko-KR" altLang="en-US" smtClean="0"/>
              <a:t>2024-01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C1D3F-BC44-44A1-AF1C-BBEBAB8F4A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522317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4D6DA-4CD8-4655-B61A-D39712F05FC0}" type="datetimeFigureOut">
              <a:rPr lang="ko-KR" altLang="en-US" smtClean="0"/>
              <a:t>2024-01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C1D3F-BC44-44A1-AF1C-BBEBAB8F4A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4356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4D6DA-4CD8-4655-B61A-D39712F05FC0}" type="datetimeFigureOut">
              <a:rPr lang="ko-KR" altLang="en-US" smtClean="0"/>
              <a:t>2024-01-1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C1D3F-BC44-44A1-AF1C-BBEBAB8F4A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43127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4D6DA-4CD8-4655-B61A-D39712F05FC0}" type="datetimeFigureOut">
              <a:rPr lang="ko-KR" altLang="en-US" smtClean="0"/>
              <a:t>2024-01-1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C1D3F-BC44-44A1-AF1C-BBEBAB8F4A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464457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4D6DA-4CD8-4655-B61A-D39712F05FC0}" type="datetimeFigureOut">
              <a:rPr lang="ko-KR" altLang="en-US" smtClean="0"/>
              <a:t>2024-01-1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C1D3F-BC44-44A1-AF1C-BBEBAB8F4A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3855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4D6DA-4CD8-4655-B61A-D39712F05FC0}" type="datetimeFigureOut">
              <a:rPr lang="ko-KR" altLang="en-US" smtClean="0"/>
              <a:t>2024-01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C1D3F-BC44-44A1-AF1C-BBEBAB8F4A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49911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4D6DA-4CD8-4655-B61A-D39712F05FC0}" type="datetimeFigureOut">
              <a:rPr lang="ko-KR" altLang="en-US" smtClean="0"/>
              <a:t>2024-01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7C1D3F-BC44-44A1-AF1C-BBEBAB8F4A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25328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E4D6DA-4CD8-4655-B61A-D39712F05FC0}" type="datetimeFigureOut">
              <a:rPr lang="ko-KR" altLang="en-US" smtClean="0"/>
              <a:t>2024-01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7C1D3F-BC44-44A1-AF1C-BBEBAB8F4A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67847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6.png"/><Relationship Id="rId4" Type="http://schemas.openxmlformats.org/officeDocument/2006/relationships/image" Target="../media/image45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png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0.png"/><Relationship Id="rId4" Type="http://schemas.openxmlformats.org/officeDocument/2006/relationships/image" Target="../media/image49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png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4.png"/><Relationship Id="rId4" Type="http://schemas.openxmlformats.org/officeDocument/2006/relationships/image" Target="../media/image5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.png"/><Relationship Id="rId5" Type="http://schemas.openxmlformats.org/officeDocument/2006/relationships/image" Target="../media/image29.png"/><Relationship Id="rId4" Type="http://schemas.openxmlformats.org/officeDocument/2006/relationships/image" Target="../media/image2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tif"/><Relationship Id="rId2" Type="http://schemas.openxmlformats.org/officeDocument/2006/relationships/image" Target="../media/image31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4.tif"/><Relationship Id="rId4" Type="http://schemas.openxmlformats.org/officeDocument/2006/relationships/image" Target="../media/image33.ti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tif"/><Relationship Id="rId2" Type="http://schemas.openxmlformats.org/officeDocument/2006/relationships/image" Target="../media/image35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8.tif"/><Relationship Id="rId4" Type="http://schemas.openxmlformats.org/officeDocument/2006/relationships/image" Target="../media/image37.ti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tif"/><Relationship Id="rId2" Type="http://schemas.openxmlformats.org/officeDocument/2006/relationships/image" Target="../media/image39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2.tif"/><Relationship Id="rId4" Type="http://schemas.openxmlformats.org/officeDocument/2006/relationships/image" Target="../media/image41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/>
          <p:cNvPicPr>
            <a:picLocks noChangeAspect="1"/>
          </p:cNvPicPr>
          <p:nvPr/>
        </p:nvPicPr>
        <p:blipFill>
          <a:blip r:embed="rId2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1100" y="238763"/>
            <a:ext cx="1900070" cy="2500996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1451873" y="2696895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NLRP3</a:t>
            </a:r>
            <a:endParaRPr lang="ko-KR" altLang="en-US" dirty="0"/>
          </a:p>
        </p:txBody>
      </p:sp>
      <p:pic>
        <p:nvPicPr>
          <p:cNvPr id="15" name="그림 1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37433" y="473727"/>
            <a:ext cx="1901294" cy="2266032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4535189" y="2696895"/>
            <a:ext cx="5469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ASC</a:t>
            </a:r>
            <a:endParaRPr lang="ko-KR" alt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213064" y="9286043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igure 2F</a:t>
            </a:r>
            <a:endParaRPr lang="ko-KR" altLang="en-US" dirty="0"/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3998" y="3625279"/>
            <a:ext cx="1859510" cy="2366087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94518" y="3437899"/>
            <a:ext cx="1893494" cy="2553467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6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843" y="6386120"/>
            <a:ext cx="1944209" cy="2354260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942257" y="5962642"/>
            <a:ext cx="18966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Cleaved caspase-1</a:t>
            </a:r>
            <a:endParaRPr lang="ko-KR" alt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4121083" y="5962642"/>
            <a:ext cx="14042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Mature IL-1</a:t>
            </a:r>
            <a:r>
              <a:rPr lang="en-US" altLang="ko-KR" dirty="0" smtClean="0">
                <a:sym typeface="Symbol" panose="05050102010706020507" pitchFamily="18" charset="2"/>
              </a:rPr>
              <a:t></a:t>
            </a:r>
            <a:endParaRPr lang="ko-KR" alt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1297839" y="8762552"/>
            <a:ext cx="841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sym typeface="Symbol" panose="05050102010706020507" pitchFamily="18" charset="2"/>
              </a:rPr>
              <a:t>-actin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24963617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13064" y="9286043"/>
            <a:ext cx="10617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igure 7B</a:t>
            </a:r>
            <a:endParaRPr lang="ko-KR" altLang="en-US" dirty="0"/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2263" y="5535216"/>
            <a:ext cx="4767309" cy="2574593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9987" y="1111166"/>
            <a:ext cx="2698812" cy="2040930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9987" y="3708348"/>
            <a:ext cx="2723809" cy="942857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4653" y="1435181"/>
            <a:ext cx="2085714" cy="2723809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916243" y="8109809"/>
            <a:ext cx="841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sym typeface="Symbol" panose="05050102010706020507" pitchFamily="18" charset="2"/>
              </a:rPr>
              <a:t>-actin</a:t>
            </a:r>
            <a:endParaRPr lang="ko-KR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2095258" y="3152096"/>
            <a:ext cx="8673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erritin</a:t>
            </a:r>
            <a:endParaRPr lang="ko-KR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1274765" y="4657975"/>
            <a:ext cx="25511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err="1"/>
              <a:t>TfR</a:t>
            </a:r>
            <a:r>
              <a:rPr lang="en-US" altLang="ko-KR" dirty="0"/>
              <a:t> (Transferrin receptor)</a:t>
            </a:r>
            <a:endParaRPr lang="ko-KR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4813579" y="4158990"/>
            <a:ext cx="119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Transferrin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47005160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13064" y="9286043"/>
            <a:ext cx="1079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igure 7D</a:t>
            </a:r>
            <a:endParaRPr lang="ko-KR" altLang="en-US" dirty="0"/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2398" y="5773167"/>
            <a:ext cx="4216893" cy="2222858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9811" y="1579073"/>
            <a:ext cx="2851602" cy="1614114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7665" y="3691725"/>
            <a:ext cx="2866667" cy="1476190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7826" y="2053188"/>
            <a:ext cx="2030848" cy="247394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899302" y="7942674"/>
            <a:ext cx="841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sym typeface="Symbol" panose="05050102010706020507" pitchFamily="18" charset="2"/>
              </a:rPr>
              <a:t>-actin</a:t>
            </a:r>
            <a:endParaRPr lang="ko-KR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1580493" y="3188828"/>
            <a:ext cx="8673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erritin</a:t>
            </a:r>
            <a:endParaRPr lang="ko-KR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864079" y="5167367"/>
            <a:ext cx="25511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err="1" smtClean="0"/>
              <a:t>TfR</a:t>
            </a:r>
            <a:r>
              <a:rPr lang="en-US" altLang="ko-KR" dirty="0" smtClean="0"/>
              <a:t> (Transferrin receptor)</a:t>
            </a:r>
            <a:endParaRPr lang="ko-KR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4446613" y="4492462"/>
            <a:ext cx="119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Transferrin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91868759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13064" y="9286043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igure 7F</a:t>
            </a:r>
            <a:endParaRPr lang="ko-KR" altLang="en-US" dirty="0"/>
          </a:p>
        </p:txBody>
      </p:sp>
      <p:pic>
        <p:nvPicPr>
          <p:cNvPr id="8" name="그림 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5675" y="5599813"/>
            <a:ext cx="2732140" cy="1141705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1507" y="2383592"/>
            <a:ext cx="2607331" cy="1917855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2732" y="5003423"/>
            <a:ext cx="2390476" cy="1923810"/>
          </a:xfrm>
          <a:prstGeom prst="rect">
            <a:avLst/>
          </a:prstGeom>
        </p:spPr>
      </p:pic>
      <p:pic>
        <p:nvPicPr>
          <p:cNvPr id="13" name="그림 12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5326" y="2570480"/>
            <a:ext cx="2323809" cy="1380952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4742894" y="6741518"/>
            <a:ext cx="841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sym typeface="Symbol" panose="05050102010706020507" pitchFamily="18" charset="2"/>
              </a:rPr>
              <a:t>-actin</a:t>
            </a:r>
            <a:endParaRPr lang="ko-KR" alt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1300550" y="4357880"/>
            <a:ext cx="8673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erritin</a:t>
            </a:r>
            <a:endParaRPr lang="ko-KR" alt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3868035" y="4020410"/>
            <a:ext cx="26312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err="1"/>
              <a:t>TfR</a:t>
            </a:r>
            <a:r>
              <a:rPr lang="en-US" altLang="ko-KR" dirty="0"/>
              <a:t> (Transferrin receptor)</a:t>
            </a:r>
            <a:endParaRPr lang="ko-KR" alt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1255199" y="6741518"/>
            <a:ext cx="119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Transferrin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4367543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13064" y="9286043"/>
            <a:ext cx="1069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igure 3A</a:t>
            </a:r>
            <a:endParaRPr lang="ko-KR" altLang="en-US" dirty="0"/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9912" y="4274998"/>
            <a:ext cx="2237521" cy="1929758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514" y="4123627"/>
            <a:ext cx="1677957" cy="2064290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1897" y="381352"/>
            <a:ext cx="2148744" cy="1868831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897" y="2672919"/>
            <a:ext cx="4669306" cy="974630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66114" y="4198796"/>
            <a:ext cx="1676121" cy="2005960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7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160" y="6513419"/>
            <a:ext cx="3536932" cy="2067248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3203646" y="6204756"/>
            <a:ext cx="6824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GPX4</a:t>
            </a:r>
            <a:endParaRPr lang="ko-KR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979135" y="6148675"/>
            <a:ext cx="668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mtClean="0"/>
              <a:t>HO-1</a:t>
            </a:r>
            <a:endParaRPr lang="ko-KR" alt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1187551" y="2255474"/>
            <a:ext cx="7655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Keap1</a:t>
            </a:r>
            <a:endParaRPr lang="ko-KR" alt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2338856" y="3700922"/>
            <a:ext cx="6014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Nrf2</a:t>
            </a:r>
            <a:endParaRPr lang="ko-KR" alt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5379945" y="6204756"/>
            <a:ext cx="5208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err="1" smtClean="0"/>
              <a:t>xCT</a:t>
            </a:r>
            <a:endParaRPr lang="ko-KR" alt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1805299" y="8536837"/>
            <a:ext cx="841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sym typeface="Symbol" panose="05050102010706020507" pitchFamily="18" charset="2"/>
              </a:rPr>
              <a:t>-actin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7739242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13064" y="9286043"/>
            <a:ext cx="10488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igure 3E</a:t>
            </a:r>
            <a:endParaRPr lang="ko-KR" altLang="en-US" dirty="0"/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6162" y="1839252"/>
            <a:ext cx="2974019" cy="1297003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8643" y="3962099"/>
            <a:ext cx="2705470" cy="1674103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8570" y="1258272"/>
            <a:ext cx="2136513" cy="1908228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3400" y="3861324"/>
            <a:ext cx="2513602" cy="1748901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7098" y="6335295"/>
            <a:ext cx="4362114" cy="1482346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4724736" y="3136948"/>
            <a:ext cx="747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ACL4</a:t>
            </a:r>
            <a:endParaRPr lang="ko-KR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1791949" y="5603662"/>
            <a:ext cx="6824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GPX4</a:t>
            </a:r>
            <a:endParaRPr lang="ko-KR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1462700" y="3195966"/>
            <a:ext cx="668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HO-1</a:t>
            </a:r>
            <a:endParaRPr lang="ko-KR" alt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4905235" y="5602556"/>
            <a:ext cx="5208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mtClean="0"/>
              <a:t>xCT</a:t>
            </a:r>
            <a:endParaRPr lang="ko-KR" alt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2527206" y="7817641"/>
            <a:ext cx="841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sym typeface="Symbol" panose="05050102010706020507" pitchFamily="18" charset="2"/>
              </a:rPr>
              <a:t>-actin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7405115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13064" y="9286043"/>
            <a:ext cx="1069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igure 5A</a:t>
            </a:r>
            <a:endParaRPr lang="ko-KR" altLang="en-US" dirty="0"/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2780" y="2073601"/>
            <a:ext cx="1913323" cy="2520727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36231" y="2087889"/>
            <a:ext cx="2122992" cy="2494226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2780" y="5310673"/>
            <a:ext cx="4527612" cy="1334392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2780" y="458645"/>
            <a:ext cx="4688401" cy="967060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6">
            <a:lum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2780" y="7308676"/>
            <a:ext cx="4091377" cy="1105778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891686" y="4671599"/>
            <a:ext cx="5469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ASC</a:t>
            </a:r>
            <a:endParaRPr lang="ko-KR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3832565" y="4565301"/>
            <a:ext cx="18966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Cleaved caspase-1</a:t>
            </a:r>
            <a:endParaRPr lang="ko-KR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2778541" y="6645065"/>
            <a:ext cx="14042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Mature IL-1</a:t>
            </a:r>
            <a:r>
              <a:rPr lang="en-US" altLang="ko-KR" dirty="0" smtClean="0">
                <a:sym typeface="Symbol" panose="05050102010706020507" pitchFamily="18" charset="2"/>
              </a:rPr>
              <a:t></a:t>
            </a:r>
            <a:endParaRPr lang="ko-KR" alt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3173984" y="1394312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NLRP3</a:t>
            </a:r>
            <a:endParaRPr lang="ko-KR" alt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2990668" y="8416341"/>
            <a:ext cx="841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sym typeface="Symbol" panose="05050102010706020507" pitchFamily="18" charset="2"/>
              </a:rPr>
              <a:t>-actin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6867356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13064" y="9286043"/>
            <a:ext cx="10617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igure 5B</a:t>
            </a:r>
            <a:endParaRPr lang="ko-KR" altLang="en-US" dirty="0"/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3236" y="1029737"/>
            <a:ext cx="2752285" cy="1340856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2001" y="3348128"/>
            <a:ext cx="2352381" cy="2228571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5080" y="3382864"/>
            <a:ext cx="2285714" cy="2428571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7600" y="6567802"/>
            <a:ext cx="5415586" cy="1217859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699904" y="2386777"/>
            <a:ext cx="747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ACL4</a:t>
            </a:r>
            <a:endParaRPr lang="ko-KR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1624470" y="5570211"/>
            <a:ext cx="6824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GPX4</a:t>
            </a:r>
            <a:endParaRPr lang="ko-KR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4720456" y="5779841"/>
            <a:ext cx="5208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mtClean="0"/>
              <a:t>xCT</a:t>
            </a:r>
            <a:endParaRPr lang="ko-KR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3094444" y="7742797"/>
            <a:ext cx="841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sym typeface="Symbol" panose="05050102010706020507" pitchFamily="18" charset="2"/>
              </a:rPr>
              <a:t>-actin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11170483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13064" y="9286043"/>
            <a:ext cx="1079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igure 5D</a:t>
            </a:r>
            <a:endParaRPr lang="ko-KR" altLang="en-US" dirty="0"/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0006" y="924701"/>
            <a:ext cx="2061490" cy="2009300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1722" y="3785978"/>
            <a:ext cx="2522959" cy="2129692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7449" y="4328153"/>
            <a:ext cx="2139946" cy="1186861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5873" y="1196145"/>
            <a:ext cx="1979018" cy="1349850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1745" y="6898357"/>
            <a:ext cx="3573354" cy="1200467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4670103" y="2934001"/>
            <a:ext cx="5469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ASC</a:t>
            </a:r>
            <a:endParaRPr lang="ko-KR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985873" y="5890569"/>
            <a:ext cx="18966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mtClean="0"/>
              <a:t>Cleaved caspase-1</a:t>
            </a:r>
            <a:endParaRPr lang="ko-KR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4182776" y="5504205"/>
            <a:ext cx="14042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Mature IL-1</a:t>
            </a:r>
            <a:r>
              <a:rPr lang="en-US" altLang="ko-KR" dirty="0" smtClean="0">
                <a:sym typeface="Symbol" panose="05050102010706020507" pitchFamily="18" charset="2"/>
              </a:rPr>
              <a:t></a:t>
            </a:r>
            <a:endParaRPr lang="ko-KR" alt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1615533" y="2668324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NLRP3</a:t>
            </a:r>
            <a:endParaRPr lang="ko-KR" alt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2907473" y="8101855"/>
            <a:ext cx="841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sym typeface="Symbol" panose="05050102010706020507" pitchFamily="18" charset="2"/>
              </a:rPr>
              <a:t>-actin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94709389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13064" y="9286043"/>
            <a:ext cx="1079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igure </a:t>
            </a:r>
            <a:r>
              <a:rPr lang="en-US" altLang="ko-KR" dirty="0" smtClean="0"/>
              <a:t>6F</a:t>
            </a:r>
            <a:endParaRPr lang="ko-KR" altLang="en-US" dirty="0"/>
          </a:p>
        </p:txBody>
      </p:sp>
      <p:pic>
        <p:nvPicPr>
          <p:cNvPr id="9" name="그림 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5222" y="1248916"/>
            <a:ext cx="1936577" cy="2783829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1652292" y="4032746"/>
            <a:ext cx="7024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SOD1</a:t>
            </a:r>
            <a:endParaRPr lang="ko-KR" altLang="en-US" dirty="0"/>
          </a:p>
        </p:txBody>
      </p:sp>
      <p:pic>
        <p:nvPicPr>
          <p:cNvPr id="13" name="그림 1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71926" y="1248916"/>
            <a:ext cx="1657350" cy="2837383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4364504" y="4032746"/>
            <a:ext cx="7024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SOD2</a:t>
            </a:r>
            <a:endParaRPr lang="ko-KR" altLang="en-US" dirty="0"/>
          </a:p>
        </p:txBody>
      </p:sp>
      <p:pic>
        <p:nvPicPr>
          <p:cNvPr id="15" name="그림 1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5051" y="4696776"/>
            <a:ext cx="2006748" cy="3648633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1259973" y="8345409"/>
            <a:ext cx="14870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CAT (catalase)</a:t>
            </a:r>
            <a:endParaRPr lang="ko-KR" altLang="en-US" dirty="0"/>
          </a:p>
        </p:txBody>
      </p:sp>
      <p:pic>
        <p:nvPicPr>
          <p:cNvPr id="17" name="그림 1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45378" y="5027661"/>
            <a:ext cx="2096289" cy="3317748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4379652" y="8345409"/>
            <a:ext cx="841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sym typeface="Symbol" panose="05050102010706020507" pitchFamily="18" charset="2"/>
              </a:rPr>
              <a:t>-actin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90609427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13064" y="9286043"/>
            <a:ext cx="10809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igure </a:t>
            </a:r>
            <a:r>
              <a:rPr lang="en-US" altLang="ko-KR" dirty="0" smtClean="0"/>
              <a:t>6H</a:t>
            </a:r>
            <a:endParaRPr lang="ko-KR" alt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1652292" y="4032746"/>
            <a:ext cx="7024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SOD1</a:t>
            </a:r>
            <a:endParaRPr lang="ko-KR" alt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4364504" y="4032746"/>
            <a:ext cx="7024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SOD2</a:t>
            </a:r>
            <a:endParaRPr lang="ko-KR" alt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1386273" y="7488255"/>
            <a:ext cx="14870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CAT (catalase)</a:t>
            </a:r>
            <a:endParaRPr lang="ko-KR" alt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4505952" y="7488255"/>
            <a:ext cx="841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sym typeface="Symbol" panose="05050102010706020507" pitchFamily="18" charset="2"/>
              </a:rPr>
              <a:t>-actin</a:t>
            </a:r>
            <a:endParaRPr lang="ko-KR" altLang="en-US" dirty="0"/>
          </a:p>
        </p:txBody>
      </p:sp>
      <p:pic>
        <p:nvPicPr>
          <p:cNvPr id="15" name="그림 1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4232" y="1809557"/>
            <a:ext cx="2478555" cy="2223189"/>
          </a:xfrm>
          <a:prstGeom prst="rect">
            <a:avLst/>
          </a:prstGeom>
        </p:spPr>
      </p:pic>
      <p:pic>
        <p:nvPicPr>
          <p:cNvPr id="16" name="그림 1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1413" y="2021038"/>
            <a:ext cx="2606726" cy="1800225"/>
          </a:xfrm>
          <a:prstGeom prst="rect">
            <a:avLst/>
          </a:prstGeom>
        </p:spPr>
      </p:pic>
      <p:pic>
        <p:nvPicPr>
          <p:cNvPr id="17" name="그림 1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4105" y="6343751"/>
            <a:ext cx="2700333" cy="1171573"/>
          </a:xfrm>
          <a:prstGeom prst="rect">
            <a:avLst/>
          </a:prstGeom>
        </p:spPr>
      </p:pic>
      <p:pic>
        <p:nvPicPr>
          <p:cNvPr id="18" name="그림 17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3040" y="4996545"/>
            <a:ext cx="2920937" cy="25187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399931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13064" y="9286043"/>
            <a:ext cx="10104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igure </a:t>
            </a:r>
            <a:r>
              <a:rPr lang="en-US" altLang="ko-KR" dirty="0" smtClean="0"/>
              <a:t>6J</a:t>
            </a:r>
            <a:endParaRPr lang="ko-KR" alt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1652292" y="4032746"/>
            <a:ext cx="7024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SOD1</a:t>
            </a:r>
            <a:endParaRPr lang="ko-KR" alt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4364504" y="4032746"/>
            <a:ext cx="7024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SOD2</a:t>
            </a:r>
            <a:endParaRPr lang="ko-KR" alt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1259973" y="8345409"/>
            <a:ext cx="14870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CAT (catalase)</a:t>
            </a:r>
            <a:endParaRPr lang="ko-KR" alt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4379652" y="8345409"/>
            <a:ext cx="841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sym typeface="Symbol" panose="05050102010706020507" pitchFamily="18" charset="2"/>
              </a:rPr>
              <a:t>-actin</a:t>
            </a:r>
            <a:endParaRPr lang="ko-KR" altLang="en-US" dirty="0"/>
          </a:p>
        </p:txBody>
      </p:sp>
      <p:pic>
        <p:nvPicPr>
          <p:cNvPr id="15" name="그림 1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6735" y="4972061"/>
            <a:ext cx="2173549" cy="3373348"/>
          </a:xfrm>
          <a:prstGeom prst="rect">
            <a:avLst/>
          </a:prstGeom>
        </p:spPr>
      </p:pic>
      <p:pic>
        <p:nvPicPr>
          <p:cNvPr id="16" name="그림 1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2350" y="927735"/>
            <a:ext cx="1782318" cy="3103692"/>
          </a:xfrm>
          <a:prstGeom prst="rect">
            <a:avLst/>
          </a:prstGeom>
        </p:spPr>
      </p:pic>
      <p:pic>
        <p:nvPicPr>
          <p:cNvPr id="17" name="그림 1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4762" y="1026648"/>
            <a:ext cx="1728777" cy="3004779"/>
          </a:xfrm>
          <a:prstGeom prst="rect">
            <a:avLst/>
          </a:prstGeom>
        </p:spPr>
      </p:pic>
      <p:pic>
        <p:nvPicPr>
          <p:cNvPr id="18" name="그림 17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4762" y="5172075"/>
            <a:ext cx="1934960" cy="31733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375946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1</TotalTime>
  <Words>132</Words>
  <Application>Microsoft Office PowerPoint</Application>
  <PresentationFormat>A4 용지(210x297mm)</PresentationFormat>
  <Paragraphs>66</Paragraphs>
  <Slides>1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2</vt:i4>
      </vt:variant>
    </vt:vector>
  </HeadingPairs>
  <TitlesOfParts>
    <vt:vector size="18" baseType="lpstr">
      <vt:lpstr>맑은 고딕</vt:lpstr>
      <vt:lpstr>Arial</vt:lpstr>
      <vt:lpstr>Calibri</vt:lpstr>
      <vt:lpstr>Calibri Light</vt:lpstr>
      <vt:lpstr>Symbo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14</cp:revision>
  <dcterms:created xsi:type="dcterms:W3CDTF">2023-09-20T05:08:12Z</dcterms:created>
  <dcterms:modified xsi:type="dcterms:W3CDTF">2024-01-15T12:16:58Z</dcterms:modified>
</cp:coreProperties>
</file>